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gif" ContentType="image/gif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Default Extension="jpeg" ContentType="image/jpeg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  <p:sldId id="262" r:id="rId3"/>
    <p:sldId id="263" r:id="rId4"/>
    <p:sldId id="264" r:id="rId5"/>
    <p:sldId id="256" r:id="rId6"/>
    <p:sldId id="266" r:id="rId7"/>
    <p:sldId id="268" r:id="rId8"/>
    <p:sldId id="267" r:id="rId9"/>
    <p:sldId id="265" r:id="rId10"/>
    <p:sldId id="257" r:id="rId11"/>
    <p:sldId id="258" r:id="rId12"/>
    <p:sldId id="259" r:id="rId13"/>
    <p:sldId id="260" r:id="rId14"/>
    <p:sldId id="261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95"/>
  </p:normalViewPr>
  <p:slideViewPr>
    <p:cSldViewPr snapToGrid="0" snapToObjects="1" showGuides="1">
      <p:cViewPr>
        <p:scale>
          <a:sx n="57" d="100"/>
          <a:sy n="57" d="100"/>
        </p:scale>
        <p:origin x="2560" y="102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21" Type="http://schemas.openxmlformats.org/officeDocument/2006/relationships/customXml" Target="../customXml/item2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7" Type="http://schemas.openxmlformats.org/officeDocument/2006/relationships/slide" Target="slides/slide6.xml"/><Relationship Id="rId16" Type="http://schemas.openxmlformats.org/officeDocument/2006/relationships/presProps" Target="presProps.xml"/><Relationship Id="rId2" Type="http://schemas.openxmlformats.org/officeDocument/2006/relationships/slide" Target="slides/slide1.xml"/><Relationship Id="rId20" Type="http://schemas.openxmlformats.org/officeDocument/2006/relationships/customXml" Target="../customXml/item1.xml"/><Relationship Id="rId11" Type="http://schemas.openxmlformats.org/officeDocument/2006/relationships/slide" Target="slides/slide1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5" Type="http://schemas.openxmlformats.org/officeDocument/2006/relationships/slide" Target="slides/slide4.xml"/><Relationship Id="rId19" Type="http://schemas.openxmlformats.org/officeDocument/2006/relationships/tableStyles" Target="tableStyles.xml"/><Relationship Id="rId10" Type="http://schemas.openxmlformats.org/officeDocument/2006/relationships/slide" Target="slides/slide9.xml"/><Relationship Id="rId14" Type="http://schemas.openxmlformats.org/officeDocument/2006/relationships/slide" Target="slides/slide13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22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0F658-89FD-C446-A5E6-C837D7386667}" type="datetimeFigureOut">
              <a:rPr lang="en-US" smtClean="0"/>
              <a:t>5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0F0E-8EEF-DC40-8B34-A0CA88D8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227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0F658-89FD-C446-A5E6-C837D7386667}" type="datetimeFigureOut">
              <a:rPr lang="en-US" smtClean="0"/>
              <a:t>5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0F0E-8EEF-DC40-8B34-A0CA88D8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451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0F658-89FD-C446-A5E6-C837D7386667}" type="datetimeFigureOut">
              <a:rPr lang="en-US" smtClean="0"/>
              <a:t>5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0F0E-8EEF-DC40-8B34-A0CA88D8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386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0F658-89FD-C446-A5E6-C837D7386667}" type="datetimeFigureOut">
              <a:rPr lang="en-US" smtClean="0"/>
              <a:t>5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0F0E-8EEF-DC40-8B34-A0CA88D8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861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0F658-89FD-C446-A5E6-C837D7386667}" type="datetimeFigureOut">
              <a:rPr lang="en-US" smtClean="0"/>
              <a:t>5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0F0E-8EEF-DC40-8B34-A0CA88D8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0227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0F658-89FD-C446-A5E6-C837D7386667}" type="datetimeFigureOut">
              <a:rPr lang="en-US" smtClean="0"/>
              <a:t>5/1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0F0E-8EEF-DC40-8B34-A0CA88D8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83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0F658-89FD-C446-A5E6-C837D7386667}" type="datetimeFigureOut">
              <a:rPr lang="en-US" smtClean="0"/>
              <a:t>5/12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0F0E-8EEF-DC40-8B34-A0CA88D8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947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0F658-89FD-C446-A5E6-C837D7386667}" type="datetimeFigureOut">
              <a:rPr lang="en-US" smtClean="0"/>
              <a:t>5/12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0F0E-8EEF-DC40-8B34-A0CA88D8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3729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0F658-89FD-C446-A5E6-C837D7386667}" type="datetimeFigureOut">
              <a:rPr lang="en-US" smtClean="0"/>
              <a:t>5/12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0F0E-8EEF-DC40-8B34-A0CA88D8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768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0F658-89FD-C446-A5E6-C837D7386667}" type="datetimeFigureOut">
              <a:rPr lang="en-US" smtClean="0"/>
              <a:t>5/1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0F0E-8EEF-DC40-8B34-A0CA88D8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240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0F658-89FD-C446-A5E6-C837D7386667}" type="datetimeFigureOut">
              <a:rPr lang="en-US" smtClean="0"/>
              <a:t>5/1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0F0E-8EEF-DC40-8B34-A0CA88D8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867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90F658-89FD-C446-A5E6-C837D7386667}" type="datetimeFigureOut">
              <a:rPr lang="en-US" smtClean="0"/>
              <a:t>5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A0F0E-8EEF-DC40-8B34-A0CA88D89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0392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0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gif"/><Relationship Id="rId4" Type="http://schemas.openxmlformats.org/officeDocument/2006/relationships/image" Target="../media/image18.g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6.gi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gif"/><Relationship Id="rId4" Type="http://schemas.openxmlformats.org/officeDocument/2006/relationships/image" Target="../media/image21.g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9.gi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gif"/><Relationship Id="rId4" Type="http://schemas.openxmlformats.org/officeDocument/2006/relationships/image" Target="../media/image24.g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2.gi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gif"/><Relationship Id="rId4" Type="http://schemas.openxmlformats.org/officeDocument/2006/relationships/image" Target="../media/image27.g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5.gi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4" Type="http://schemas.openxmlformats.org/officeDocument/2006/relationships/image" Target="../media/image3.g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g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gif"/><Relationship Id="rId4" Type="http://schemas.openxmlformats.org/officeDocument/2006/relationships/image" Target="../media/image6.g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gi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gif"/><Relationship Id="rId4" Type="http://schemas.openxmlformats.org/officeDocument/2006/relationships/image" Target="../media/image9.g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g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gif"/><Relationship Id="rId4" Type="http://schemas.openxmlformats.org/officeDocument/2006/relationships/image" Target="../media/image12.g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0.gi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gif"/><Relationship Id="rId4" Type="http://schemas.openxmlformats.org/officeDocument/2006/relationships/image" Target="../media/image15.g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3.gi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212715"/>
          </a:xfrm>
        </p:spPr>
        <p:txBody>
          <a:bodyPr>
            <a:normAutofit/>
          </a:bodyPr>
          <a:lstStyle/>
          <a:p>
            <a:pPr algn="r"/>
            <a:r>
              <a:rPr lang="en-US" sz="3000" b="1" dirty="0" smtClean="0">
                <a:latin typeface="Helvetica Neue" charset="0"/>
                <a:ea typeface="Helvetica Neue" charset="0"/>
                <a:cs typeface="Helvetica Neue" charset="0"/>
              </a:rPr>
              <a:t>Supplementary Data 2</a:t>
            </a:r>
            <a:br>
              <a:rPr lang="en-US" sz="3000" b="1" dirty="0" smtClean="0">
                <a:latin typeface="Helvetica Neue" charset="0"/>
                <a:ea typeface="Helvetica Neue" charset="0"/>
                <a:cs typeface="Helvetica Neue" charset="0"/>
              </a:rPr>
            </a:br>
            <a:r>
              <a:rPr lang="en-US" sz="3000" dirty="0" smtClean="0">
                <a:latin typeface="Helvetica Neue" charset="0"/>
                <a:ea typeface="Helvetica Neue" charset="0"/>
                <a:cs typeface="Helvetica Neue" charset="0"/>
              </a:rPr>
              <a:t/>
            </a:r>
            <a:br>
              <a:rPr lang="en-US" sz="3000" dirty="0" smtClean="0">
                <a:latin typeface="Helvetica Neue" charset="0"/>
                <a:ea typeface="Helvetica Neue" charset="0"/>
                <a:cs typeface="Helvetica Neue" charset="0"/>
              </a:rPr>
            </a:br>
            <a:r>
              <a:rPr lang="en-US" sz="3000" dirty="0" smtClean="0">
                <a:solidFill>
                  <a:srgbClr val="000000"/>
                </a:solidFill>
                <a:latin typeface="Helvetica Neue" charset="0"/>
                <a:ea typeface="Helvetica Neue" charset="0"/>
                <a:cs typeface="Helvetica Neue" charset="0"/>
              </a:rPr>
              <a:t>Dose </a:t>
            </a:r>
            <a:r>
              <a:rPr lang="en-US" sz="3000" dirty="0">
                <a:solidFill>
                  <a:srgbClr val="000000"/>
                </a:solidFill>
                <a:latin typeface="Helvetica Neue" charset="0"/>
                <a:ea typeface="Helvetica Neue" charset="0"/>
                <a:cs typeface="Helvetica Neue" charset="0"/>
              </a:rPr>
              <a:t>and time dependency of stress pathway responses during chemical </a:t>
            </a:r>
            <a:r>
              <a:rPr lang="en-US" sz="3000" dirty="0" smtClean="0">
                <a:solidFill>
                  <a:srgbClr val="000000"/>
                </a:solidFill>
                <a:latin typeface="Helvetica Neue" charset="0"/>
                <a:ea typeface="Helvetica Neue" charset="0"/>
                <a:cs typeface="Helvetica Neue" charset="0"/>
              </a:rPr>
              <a:t>exposure</a:t>
            </a:r>
            <a:r>
              <a:rPr lang="en-US" sz="3000" dirty="0">
                <a:latin typeface="Helvetica Neue" charset="0"/>
                <a:ea typeface="Helvetica Neue" charset="0"/>
                <a:cs typeface="Helvetica Neue" charset="0"/>
              </a:rPr>
              <a:t/>
            </a:r>
            <a:br>
              <a:rPr lang="en-US" sz="3000" dirty="0">
                <a:latin typeface="Helvetica Neue" charset="0"/>
                <a:ea typeface="Helvetica Neue" charset="0"/>
                <a:cs typeface="Helvetica Neue" charset="0"/>
              </a:rPr>
            </a:br>
            <a:r>
              <a:rPr lang="en-US" sz="2000" dirty="0" smtClean="0">
                <a:latin typeface="Helvetica Neue" charset="0"/>
                <a:ea typeface="Helvetica Neue" charset="0"/>
                <a:cs typeface="Helvetica Neue" charset="0"/>
              </a:rPr>
              <a:t>To </a:t>
            </a:r>
            <a:r>
              <a:rPr lang="en-US" sz="2000" dirty="0" smtClean="0">
                <a:latin typeface="Helvetica Neue" charset="0"/>
                <a:ea typeface="Helvetica Neue" charset="0"/>
                <a:cs typeface="Helvetica Neue" charset="0"/>
              </a:rPr>
              <a:t>visualize </a:t>
            </a:r>
            <a:r>
              <a:rPr lang="en-US" sz="2000" dirty="0" smtClean="0">
                <a:latin typeface="Helvetica Neue" charset="0"/>
                <a:ea typeface="Helvetica Neue" charset="0"/>
                <a:cs typeface="Helvetica Neue" charset="0"/>
              </a:rPr>
              <a:t>.gif files </a:t>
            </a:r>
            <a:r>
              <a:rPr lang="en-US" sz="2000" dirty="0" smtClean="0">
                <a:latin typeface="Helvetica Neue" charset="0"/>
                <a:ea typeface="Helvetica Neue" charset="0"/>
                <a:cs typeface="Helvetica Neue" charset="0"/>
              </a:rPr>
              <a:t>open </a:t>
            </a:r>
            <a:r>
              <a:rPr lang="en-US" sz="2000" dirty="0" smtClean="0">
                <a:latin typeface="Helvetica Neue" charset="0"/>
                <a:ea typeface="Helvetica Neue" charset="0"/>
                <a:cs typeface="Helvetica Neue" charset="0"/>
              </a:rPr>
              <a:t>this presentation as a slide show</a:t>
            </a:r>
            <a:endParaRPr lang="en-US" sz="2000" dirty="0">
              <a:latin typeface="Helvetica Neue" charset="0"/>
              <a:ea typeface="Helvetica Neue" charset="0"/>
              <a:cs typeface="Helvetica Neue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1086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1"/>
            <a:ext cx="5952025" cy="351400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4545" y="-3206"/>
            <a:ext cx="5957455" cy="351720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5353" y="3514000"/>
            <a:ext cx="5521293" cy="325970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0610" y="2917502"/>
            <a:ext cx="8360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Low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531969" y="2917502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Middle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56260" y="6404370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High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672753" y="6081204"/>
            <a:ext cx="32144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NRF2</a:t>
            </a:r>
          </a:p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Carcinogenic compounds</a:t>
            </a:r>
          </a:p>
        </p:txBody>
      </p:sp>
    </p:spTree>
    <p:extLst>
      <p:ext uri="{BB962C8B-B14F-4D97-AF65-F5344CB8AC3E}">
        <p14:creationId xmlns:p14="http://schemas.microsoft.com/office/powerpoint/2010/main" val="2539000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2745" y="3429000"/>
            <a:ext cx="5735783" cy="3386334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7673" y="0"/>
            <a:ext cx="5887050" cy="347564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5943600" cy="350902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0610" y="2917502"/>
            <a:ext cx="8360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Low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531969" y="2917502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Middle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56260" y="6404370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High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672753" y="6081204"/>
            <a:ext cx="32144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NRF2</a:t>
            </a:r>
          </a:p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DILI compounds</a:t>
            </a:r>
          </a:p>
        </p:txBody>
      </p:sp>
    </p:spTree>
    <p:extLst>
      <p:ext uri="{BB962C8B-B14F-4D97-AF65-F5344CB8AC3E}">
        <p14:creationId xmlns:p14="http://schemas.microsoft.com/office/powerpoint/2010/main" val="20674591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601201" y="5605284"/>
            <a:ext cx="368530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0" dirty="0" smtClean="0">
                <a:latin typeface="Arial" charset="0"/>
                <a:ea typeface="Arial" charset="0"/>
                <a:cs typeface="Arial" charset="0"/>
              </a:rPr>
              <a:t>TP53</a:t>
            </a:r>
            <a:endParaRPr lang="en-US" sz="6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29172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4892" y="3605136"/>
            <a:ext cx="5872834" cy="273447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5374" y="584200"/>
            <a:ext cx="5886626" cy="274089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90622"/>
            <a:ext cx="5872834" cy="273447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0610" y="593928"/>
            <a:ext cx="8360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Low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1074137" y="593928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Middle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111387" y="3664125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High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672753" y="6081204"/>
            <a:ext cx="32144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TP53</a:t>
            </a:r>
          </a:p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Carcinogenic compounds</a:t>
            </a:r>
          </a:p>
        </p:txBody>
      </p:sp>
    </p:spTree>
    <p:extLst>
      <p:ext uri="{BB962C8B-B14F-4D97-AF65-F5344CB8AC3E}">
        <p14:creationId xmlns:p14="http://schemas.microsoft.com/office/powerpoint/2010/main" val="19297494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7715" y="3625470"/>
            <a:ext cx="6018601" cy="323253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8744" y="193970"/>
            <a:ext cx="6023256" cy="323503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3970"/>
            <a:ext cx="6023256" cy="323503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0610" y="388425"/>
            <a:ext cx="8360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Low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1074137" y="388425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Middle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70115" y="3844234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High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672753" y="6081204"/>
            <a:ext cx="32144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TP53</a:t>
            </a:r>
          </a:p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DILI compounds</a:t>
            </a:r>
          </a:p>
        </p:txBody>
      </p:sp>
    </p:spTree>
    <p:extLst>
      <p:ext uri="{BB962C8B-B14F-4D97-AF65-F5344CB8AC3E}">
        <p14:creationId xmlns:p14="http://schemas.microsoft.com/office/powerpoint/2010/main" val="1759188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601201" y="5605284"/>
            <a:ext cx="368530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0" dirty="0" smtClean="0">
                <a:latin typeface="Arial" charset="0"/>
                <a:ea typeface="Arial" charset="0"/>
                <a:cs typeface="Arial" charset="0"/>
              </a:rPr>
              <a:t>ER</a:t>
            </a:r>
            <a:endParaRPr lang="en-US" sz="6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78675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2733" y="3629129"/>
            <a:ext cx="5240020" cy="322887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27197" y="1"/>
            <a:ext cx="5564802" cy="342900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5564803" cy="3429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59724" y="174302"/>
            <a:ext cx="8360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Low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1074136" y="174302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Middle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774346" y="3760714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High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672753" y="6081204"/>
            <a:ext cx="32144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ER</a:t>
            </a:r>
          </a:p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Carcinogenic compounds</a:t>
            </a:r>
          </a:p>
        </p:txBody>
      </p:sp>
    </p:spTree>
    <p:extLst>
      <p:ext uri="{BB962C8B-B14F-4D97-AF65-F5344CB8AC3E}">
        <p14:creationId xmlns:p14="http://schemas.microsoft.com/office/powerpoint/2010/main" val="28338941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5247" y="0"/>
            <a:ext cx="5846753" cy="360273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5846753" cy="360273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41436" y="3059668"/>
            <a:ext cx="8360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Low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421033" y="3059668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Middle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672753" y="6081204"/>
            <a:ext cx="32144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ER</a:t>
            </a:r>
          </a:p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DILI compounds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7342" y="3636916"/>
            <a:ext cx="5227383" cy="322108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807342" y="6358203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High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4849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381745" y="5568708"/>
            <a:ext cx="368530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0" smtClean="0">
                <a:latin typeface="Arial" charset="0"/>
                <a:ea typeface="Arial" charset="0"/>
                <a:cs typeface="Arial" charset="0"/>
              </a:rPr>
              <a:t>NF-kB</a:t>
            </a:r>
            <a:endParaRPr lang="en-US" sz="6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2433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8807" y="3482633"/>
            <a:ext cx="5477764" cy="3375367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8544" y="11947"/>
            <a:ext cx="5553456" cy="3422008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5564803" cy="3429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728781" y="3008942"/>
            <a:ext cx="8360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Low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1074137" y="3008942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Middle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881956" y="6423436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High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370065" y="6081204"/>
            <a:ext cx="45171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NF-kB</a:t>
            </a:r>
          </a:p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Carcinogenic compounds</a:t>
            </a:r>
          </a:p>
        </p:txBody>
      </p:sp>
    </p:spTree>
    <p:extLst>
      <p:ext uri="{BB962C8B-B14F-4D97-AF65-F5344CB8AC3E}">
        <p14:creationId xmlns:p14="http://schemas.microsoft.com/office/powerpoint/2010/main" val="14167185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5181" y="3583530"/>
            <a:ext cx="5294884" cy="326267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7104" y="0"/>
            <a:ext cx="5644895" cy="3478352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5564803" cy="3429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979562" y="54864"/>
            <a:ext cx="8360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Low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1074136" y="54864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Middle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508234" y="3687746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High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370065" y="6081204"/>
            <a:ext cx="45171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NF-kB</a:t>
            </a:r>
          </a:p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DILI compounds</a:t>
            </a:r>
          </a:p>
        </p:txBody>
      </p:sp>
    </p:spTree>
    <p:extLst>
      <p:ext uri="{BB962C8B-B14F-4D97-AF65-F5344CB8AC3E}">
        <p14:creationId xmlns:p14="http://schemas.microsoft.com/office/powerpoint/2010/main" val="1666250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6385" y="3572256"/>
            <a:ext cx="5006848" cy="3285744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1151" y="91441"/>
            <a:ext cx="5260847" cy="345243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1440"/>
            <a:ext cx="5268913" cy="345772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0610" y="3008942"/>
            <a:ext cx="8360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Low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004302" y="3008942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Middle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669876" y="6404369"/>
            <a:ext cx="1117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charset="0"/>
                <a:ea typeface="Arial" charset="0"/>
                <a:cs typeface="Arial" charset="0"/>
              </a:rPr>
              <a:t>High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370065" y="6081204"/>
            <a:ext cx="45171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NF-kB</a:t>
            </a:r>
          </a:p>
          <a:p>
            <a:pPr algn="r"/>
            <a:r>
              <a:rPr lang="en-US" dirty="0" smtClean="0">
                <a:latin typeface="Arial" charset="0"/>
                <a:ea typeface="Arial" charset="0"/>
                <a:cs typeface="Arial" charset="0"/>
              </a:rPr>
              <a:t>Non-DILI/non-carcinogenic compounds</a:t>
            </a:r>
          </a:p>
        </p:txBody>
      </p:sp>
    </p:spTree>
    <p:extLst>
      <p:ext uri="{BB962C8B-B14F-4D97-AF65-F5344CB8AC3E}">
        <p14:creationId xmlns:p14="http://schemas.microsoft.com/office/powerpoint/2010/main" val="14796702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601201" y="5605284"/>
            <a:ext cx="368530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0" smtClean="0">
                <a:latin typeface="Arial" charset="0"/>
                <a:ea typeface="Arial" charset="0"/>
                <a:cs typeface="Arial" charset="0"/>
              </a:rPr>
              <a:t>NRF2</a:t>
            </a:r>
            <a:endParaRPr lang="en-US" sz="6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9648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C480E16A9EBBC47842AE9AD0FDCC171" ma:contentTypeVersion="7" ma:contentTypeDescription="Create a new document." ma:contentTypeScope="" ma:versionID="483c1938a3800a7ac932fba602f44290">
  <xsd:schema xmlns:xsd="http://www.w3.org/2001/XMLSchema" xmlns:p="http://schemas.microsoft.com/office/2006/metadata/properties" xmlns:ns2="1d4c4d7a-82d6-4a92-8b8c-bdc4976f33c4" targetNamespace="http://schemas.microsoft.com/office/2006/metadata/properties" ma:root="true" ma:fieldsID="64aa8e21bd92f30e6a9b3f4acdc0967f" ns2:_="">
    <xsd:import namespace="1d4c4d7a-82d6-4a92-8b8c-bdc4976f33c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1d4c4d7a-82d6-4a92-8b8c-bdc4976f33c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1d4c4d7a-82d6-4a92-8b8c-bdc4976f33c4">Presentation 1.PPTX</DocumentId>
    <IsDeleted xmlns="1d4c4d7a-82d6-4a92-8b8c-bdc4976f33c4">false</IsDeleted>
    <StageName xmlns="1d4c4d7a-82d6-4a92-8b8c-bdc4976f33c4" xsi:nil="true"/>
    <TitleName xmlns="1d4c4d7a-82d6-4a92-8b8c-bdc4976f33c4">Presentation 1.PPTX</TitleName>
    <DocumentType xmlns="1d4c4d7a-82d6-4a92-8b8c-bdc4976f33c4">Presentation</DocumentType>
    <FileFormat xmlns="1d4c4d7a-82d6-4a92-8b8c-bdc4976f33c4">PPTX</FileFormat>
    <Checked_x0020_Out_x0020_To xmlns="1d4c4d7a-82d6-4a92-8b8c-bdc4976f33c4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C568F3B1-C975-432C-8E15-2531595DA607}"/>
</file>

<file path=customXml/itemProps2.xml><?xml version="1.0" encoding="utf-8"?>
<ds:datastoreItem xmlns:ds="http://schemas.openxmlformats.org/officeDocument/2006/customXml" ds:itemID="{5700E7FF-BDBD-40D6-9CA2-530E4CA95152}"/>
</file>

<file path=customXml/itemProps3.xml><?xml version="1.0" encoding="utf-8"?>
<ds:datastoreItem xmlns:ds="http://schemas.openxmlformats.org/officeDocument/2006/customXml" ds:itemID="{276776EE-692B-407C-839B-6CD5251FA385}"/>
</file>

<file path=docProps/app.xml><?xml version="1.0" encoding="utf-8"?>
<Properties xmlns="http://schemas.openxmlformats.org/officeDocument/2006/extended-properties" xmlns:vt="http://schemas.openxmlformats.org/officeDocument/2006/docPropsVTypes">
  <TotalTime>409</TotalTime>
  <Words>61</Words>
  <Application>Microsoft Macintosh PowerPoint</Application>
  <PresentationFormat>Widescreen</PresentationFormat>
  <Paragraphs>50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Calibri</vt:lpstr>
      <vt:lpstr>Calibri Light</vt:lpstr>
      <vt:lpstr>Helvetica Neue</vt:lpstr>
      <vt:lpstr>Arial</vt:lpstr>
      <vt:lpstr>Office Theme</vt:lpstr>
      <vt:lpstr>Supplementary Data 2  Dose and time dependency of stress pathway responses during chemical exposure To visualize .gif files open this presentation as a slide show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rezinha Souza</dc:creator>
  <cp:lastModifiedBy>Terezinha Souza</cp:lastModifiedBy>
  <cp:revision>18</cp:revision>
  <dcterms:created xsi:type="dcterms:W3CDTF">2017-05-09T12:26:38Z</dcterms:created>
  <dcterms:modified xsi:type="dcterms:W3CDTF">2017-05-12T07:50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C480E16A9EBBC47842AE9AD0FDCC171</vt:lpwstr>
  </property>
</Properties>
</file>